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74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9839305801060583E-2"/>
          <c:y val="0.1268034188034188"/>
          <c:w val="0.90521738354134307"/>
          <c:h val="0.784675344878832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ntioxidant Enzymes Graphs'!$F$40:$F$41</c:f>
              <c:strCache>
                <c:ptCount val="2"/>
                <c:pt idx="0">
                  <c:v>APX</c:v>
                </c:pt>
                <c:pt idx="1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F$42:$F$48</c:f>
              <c:numCache>
                <c:formatCode>0.00</c:formatCode>
                <c:ptCount val="7"/>
                <c:pt idx="0">
                  <c:v>0.42666666666666669</c:v>
                </c:pt>
                <c:pt idx="1">
                  <c:v>4.13</c:v>
                </c:pt>
                <c:pt idx="2">
                  <c:v>3.2433333333333336</c:v>
                </c:pt>
                <c:pt idx="3">
                  <c:v>0.57399999999999995</c:v>
                </c:pt>
                <c:pt idx="4">
                  <c:v>0.28466666666666662</c:v>
                </c:pt>
                <c:pt idx="5">
                  <c:v>3.4766666666666666</c:v>
                </c:pt>
                <c:pt idx="6">
                  <c:v>3.59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CD-4067-955B-9B0AE82CE1FA}"/>
            </c:ext>
          </c:extLst>
        </c:ser>
        <c:ser>
          <c:idx val="1"/>
          <c:order val="1"/>
          <c:tx>
            <c:strRef>
              <c:f>'Antioxidant Enzymes Graphs'!$G$40:$G$41</c:f>
              <c:strCache>
                <c:ptCount val="2"/>
                <c:pt idx="0">
                  <c:v>APX</c:v>
                </c:pt>
                <c:pt idx="1">
                  <c:v>Salinit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G$42:$G$48</c:f>
              <c:numCache>
                <c:formatCode>0.00</c:formatCode>
                <c:ptCount val="7"/>
                <c:pt idx="0">
                  <c:v>2.8373333333333335</c:v>
                </c:pt>
                <c:pt idx="1">
                  <c:v>5.137999999999999</c:v>
                </c:pt>
                <c:pt idx="2">
                  <c:v>3.97</c:v>
                </c:pt>
                <c:pt idx="3">
                  <c:v>4.0133333333333328</c:v>
                </c:pt>
                <c:pt idx="4">
                  <c:v>4.5266666666666664</c:v>
                </c:pt>
                <c:pt idx="5">
                  <c:v>3.4906666666666664</c:v>
                </c:pt>
                <c:pt idx="6">
                  <c:v>5.277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CD-4067-955B-9B0AE82CE1FA}"/>
            </c:ext>
          </c:extLst>
        </c:ser>
        <c:ser>
          <c:idx val="2"/>
          <c:order val="2"/>
          <c:tx>
            <c:strRef>
              <c:f>'Antioxidant Enzymes Graphs'!$H$40:$H$41</c:f>
              <c:strCache>
                <c:ptCount val="2"/>
                <c:pt idx="0">
                  <c:v>CAT</c:v>
                </c:pt>
                <c:pt idx="1">
                  <c:v>Contro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H$42:$H$48</c:f>
              <c:numCache>
                <c:formatCode>0.00</c:formatCode>
                <c:ptCount val="7"/>
                <c:pt idx="0">
                  <c:v>0.27479999999999999</c:v>
                </c:pt>
                <c:pt idx="1">
                  <c:v>0.26066666666666666</c:v>
                </c:pt>
                <c:pt idx="2">
                  <c:v>0.14066666666666669</c:v>
                </c:pt>
                <c:pt idx="3">
                  <c:v>0.35653333333333331</c:v>
                </c:pt>
                <c:pt idx="4">
                  <c:v>0.33640000000000003</c:v>
                </c:pt>
                <c:pt idx="5">
                  <c:v>0.25453333333333333</c:v>
                </c:pt>
                <c:pt idx="6" formatCode="0.000">
                  <c:v>7.293333333333333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3CD-4067-955B-9B0AE82CE1FA}"/>
            </c:ext>
          </c:extLst>
        </c:ser>
        <c:ser>
          <c:idx val="3"/>
          <c:order val="3"/>
          <c:tx>
            <c:strRef>
              <c:f>'Antioxidant Enzymes Graphs'!$I$40:$I$41</c:f>
              <c:strCache>
                <c:ptCount val="2"/>
                <c:pt idx="0">
                  <c:v>CAT</c:v>
                </c:pt>
                <c:pt idx="1">
                  <c:v>Salinity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I$42:$I$48</c:f>
              <c:numCache>
                <c:formatCode>0.00</c:formatCode>
                <c:ptCount val="7"/>
                <c:pt idx="0">
                  <c:v>0.29319999999999996</c:v>
                </c:pt>
                <c:pt idx="1">
                  <c:v>0.32000000000000006</c:v>
                </c:pt>
                <c:pt idx="2">
                  <c:v>0.26800000000000002</c:v>
                </c:pt>
                <c:pt idx="3">
                  <c:v>0.28266666666666668</c:v>
                </c:pt>
                <c:pt idx="4">
                  <c:v>0.31613333333333338</c:v>
                </c:pt>
                <c:pt idx="5">
                  <c:v>0.3066666666666667</c:v>
                </c:pt>
                <c:pt idx="6" formatCode="0.000">
                  <c:v>7.466666666666667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3CD-4067-955B-9B0AE82CE1FA}"/>
            </c:ext>
          </c:extLst>
        </c:ser>
        <c:ser>
          <c:idx val="4"/>
          <c:order val="4"/>
          <c:tx>
            <c:strRef>
              <c:f>'Antioxidant Enzymes Graphs'!$J$40:$J$41</c:f>
              <c:strCache>
                <c:ptCount val="2"/>
                <c:pt idx="0">
                  <c:v>GR</c:v>
                </c:pt>
                <c:pt idx="1">
                  <c:v>Control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J$42:$J$48</c:f>
              <c:numCache>
                <c:formatCode>0.00</c:formatCode>
                <c:ptCount val="7"/>
                <c:pt idx="0">
                  <c:v>0.47120000000000006</c:v>
                </c:pt>
                <c:pt idx="1">
                  <c:v>0.55799999999999994</c:v>
                </c:pt>
                <c:pt idx="2">
                  <c:v>0.34719999999999995</c:v>
                </c:pt>
                <c:pt idx="3">
                  <c:v>1.0726000000000002</c:v>
                </c:pt>
                <c:pt idx="4">
                  <c:v>0.41539999999999999</c:v>
                </c:pt>
                <c:pt idx="5">
                  <c:v>2.3560000000000003</c:v>
                </c:pt>
                <c:pt idx="6">
                  <c:v>0.372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3CD-4067-955B-9B0AE82CE1FA}"/>
            </c:ext>
          </c:extLst>
        </c:ser>
        <c:ser>
          <c:idx val="5"/>
          <c:order val="5"/>
          <c:tx>
            <c:strRef>
              <c:f>'Antioxidant Enzymes Graphs'!$K$40:$K$41</c:f>
              <c:strCache>
                <c:ptCount val="2"/>
                <c:pt idx="0">
                  <c:v>GR</c:v>
                </c:pt>
                <c:pt idx="1">
                  <c:v>Salinity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K$42:$K$48</c:f>
              <c:numCache>
                <c:formatCode>0.00</c:formatCode>
                <c:ptCount val="7"/>
                <c:pt idx="0">
                  <c:v>0.65720000000000001</c:v>
                </c:pt>
                <c:pt idx="1">
                  <c:v>0.99820000000000009</c:v>
                </c:pt>
                <c:pt idx="2">
                  <c:v>2.3249999999999997</c:v>
                </c:pt>
                <c:pt idx="3">
                  <c:v>3.2359999999999993</c:v>
                </c:pt>
                <c:pt idx="4">
                  <c:v>2.6659999999999999</c:v>
                </c:pt>
                <c:pt idx="5">
                  <c:v>0.57969999999999999</c:v>
                </c:pt>
                <c:pt idx="6">
                  <c:v>0.5703999999999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3CD-4067-955B-9B0AE82CE1FA}"/>
            </c:ext>
          </c:extLst>
        </c:ser>
        <c:ser>
          <c:idx val="6"/>
          <c:order val="6"/>
          <c:tx>
            <c:strRef>
              <c:f>'Antioxidant Enzymes Graphs'!$L$40:$L$41</c:f>
              <c:strCache>
                <c:ptCount val="2"/>
                <c:pt idx="0">
                  <c:v>SOD</c:v>
                </c:pt>
                <c:pt idx="1">
                  <c:v>Control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L$42:$L$48</c:f>
              <c:numCache>
                <c:formatCode>0.00</c:formatCode>
                <c:ptCount val="7"/>
                <c:pt idx="0">
                  <c:v>1.4660333333333335</c:v>
                </c:pt>
                <c:pt idx="1">
                  <c:v>1.5518666666666669</c:v>
                </c:pt>
                <c:pt idx="2">
                  <c:v>1.6480000000000004</c:v>
                </c:pt>
                <c:pt idx="3">
                  <c:v>0.63516666666666677</c:v>
                </c:pt>
                <c:pt idx="4">
                  <c:v>1.6686000000000003</c:v>
                </c:pt>
                <c:pt idx="5">
                  <c:v>1.1021000000000001</c:v>
                </c:pt>
                <c:pt idx="6">
                  <c:v>1.37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3CD-4067-955B-9B0AE82CE1FA}"/>
            </c:ext>
          </c:extLst>
        </c:ser>
        <c:ser>
          <c:idx val="7"/>
          <c:order val="7"/>
          <c:tx>
            <c:strRef>
              <c:f>'Antioxidant Enzymes Graphs'!$M$40:$M$41</c:f>
              <c:strCache>
                <c:ptCount val="2"/>
                <c:pt idx="0">
                  <c:v>SOD</c:v>
                </c:pt>
                <c:pt idx="1">
                  <c:v>Salinity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ntioxidant Enzymes Graphs'!$E$42:$E$48</c:f>
              <c:strCache>
                <c:ptCount val="7"/>
                <c:pt idx="0">
                  <c:v>Sohag-5 </c:v>
                </c:pt>
                <c:pt idx="1">
                  <c:v>Kandahar  </c:v>
                </c:pt>
                <c:pt idx="2">
                  <c:v>Ghati </c:v>
                </c:pt>
                <c:pt idx="3">
                  <c:v>Javelin 48 </c:v>
                </c:pt>
                <c:pt idx="4">
                  <c:v>1049</c:v>
                </c:pt>
                <c:pt idx="5">
                  <c:v>1018d </c:v>
                </c:pt>
                <c:pt idx="6">
                  <c:v>Kule </c:v>
                </c:pt>
              </c:strCache>
            </c:strRef>
          </c:cat>
          <c:val>
            <c:numRef>
              <c:f>'Antioxidant Enzymes Graphs'!$M$42:$M$48</c:f>
              <c:numCache>
                <c:formatCode>0.00</c:formatCode>
                <c:ptCount val="7"/>
                <c:pt idx="0">
                  <c:v>1.3252666666666668</c:v>
                </c:pt>
                <c:pt idx="1">
                  <c:v>1.5930666666666671</c:v>
                </c:pt>
                <c:pt idx="2">
                  <c:v>1.9741666666666671</c:v>
                </c:pt>
                <c:pt idx="3">
                  <c:v>1.4694666666666667</c:v>
                </c:pt>
                <c:pt idx="4">
                  <c:v>2.1973333333333334</c:v>
                </c:pt>
                <c:pt idx="5">
                  <c:v>1.9879000000000004</c:v>
                </c:pt>
                <c:pt idx="6">
                  <c:v>1.4729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3CD-4067-955B-9B0AE82CE1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722888"/>
        <c:axId val="213724456"/>
      </c:barChart>
      <c:catAx>
        <c:axId val="2137228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notypes</a:t>
                </a:r>
              </a:p>
            </c:rich>
          </c:tx>
          <c:layout>
            <c:manualLayout>
              <c:xMode val="edge"/>
              <c:yMode val="edge"/>
              <c:x val="0.48453971359556569"/>
              <c:y val="0.957246167969696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3724456"/>
        <c:crosses val="autoZero"/>
        <c:auto val="1"/>
        <c:lblAlgn val="ctr"/>
        <c:lblOffset val="100"/>
        <c:noMultiLvlLbl val="0"/>
      </c:catAx>
      <c:valAx>
        <c:axId val="2137244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u="none" strike="noStrike" kern="1200" baseline="0">
                    <a:solidFill>
                      <a:sysClr val="windowText" lastClr="000000"/>
                    </a:solidFill>
                    <a:cs typeface="+mn-cs"/>
                  </a:rPr>
                  <a:t>µg</a:t>
                </a:r>
                <a:r>
                  <a:rPr lang="ar-EG" sz="1200" b="1" i="0" u="none" strike="noStrike" kern="1200" baseline="0">
                    <a:solidFill>
                      <a:sysClr val="windowText" lastClr="000000"/>
                    </a:solidFill>
                    <a:cs typeface="+mn-cs"/>
                  </a:rPr>
                  <a:t>/</a:t>
                </a:r>
                <a:r>
                  <a:rPr lang="en-US" sz="1200" b="1" i="0" u="none" strike="noStrike" kern="1200" baseline="0">
                    <a:solidFill>
                      <a:sysClr val="windowText" lastClr="000000"/>
                    </a:solidFill>
                    <a:cs typeface="+mn-cs"/>
                  </a:rPr>
                  <a:t>g </a:t>
                </a:r>
                <a:r>
                  <a:rPr lang="en-US"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+mn-cs"/>
                  </a:rPr>
                  <a:t>Protei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37228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285006007136885"/>
          <c:y val="4.4249229741267319E-2"/>
          <c:w val="0.83371673998580931"/>
          <c:h val="0.110257217847769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50C9B5-F264-68B6-B85D-A61DF08D2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5230E3-C0F9-E747-8F68-2DEFB7C06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E9C1C7-12D3-3C01-6B43-906DF65E8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007F65-72A1-BFB7-112F-61E717DFF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7678DB-2A45-71E9-62DF-8EF9AC6ED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49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5194FF-0408-D700-CA11-DDE234F537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61CE21-843F-C998-7361-8485854670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854502-0264-E52D-A5B2-65F27739A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5BBF6D-195C-8EDD-1B46-913FDE4CE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845FEC-4294-8A33-CCE9-F29F07588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3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E973C2-43F1-B79B-555B-CA90A2919D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8DF660-B89B-C6F6-B833-4EB239957A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F27E9-1B0F-1450-3390-C708EC39F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417D34-EDEE-C34C-9003-B361EC1DB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F70A75-9A79-6621-ACDC-9416B6B46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172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330A2-1CB0-8A8A-CB2B-C2476105A5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A40D9F-ED63-B271-95B8-A8217DC339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CB9CF-1B3C-3E44-7344-3FC5A9B36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4A1B3-0F41-0B05-1E89-0B941387C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D3B29D-2B1A-A45C-FD1F-B42DC7049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19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8864E1-9128-08FE-664C-1F5E99E90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B8235F-B7AB-1D26-A2FA-E556713491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855B90-A308-65D3-C640-9769B2729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FC8CAA-B695-68C8-E549-AEB9D5EC3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A5D103-2365-18B8-FC37-E91579B1A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441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86B79-2A7E-E79A-4729-2FCFB88630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C334DB-56CB-4C39-B384-B16449DC6D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932D99-2893-39FE-6051-EC79BA7805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5AC28B-D2CB-6C22-3CA5-AB67B18C0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E437DB-64A5-2883-EEDB-E2C92BC52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0079F7-3C22-51AD-70F8-E418D1F50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433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42EBD-A3CC-32BB-40E6-7C7B445B5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962D9A-8BF3-F90A-12CA-22FCD6D1BF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66997E-0A03-B2B3-D2D3-D9E8C21593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002CEA-254A-08B5-4A83-114D338275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A07A0C-7994-4E11-FD10-19E42CCAD0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42C99C-4A73-AF7B-E857-72990193C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B5AF69-6CB7-947F-1F76-3E2B3F7EF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C0BBEA-2469-4A14-7079-0F6AA6CE7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798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4AE9B-6C49-AFF3-54BC-E6B038458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5A3024-48CB-2339-B42B-619DCAC3B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FBE3E8-D2AC-ED3A-7F40-807ACE64E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E8F2E3-0AC7-25D9-32BE-F36620E20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193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2C0273-D323-B1FB-47FD-3A7DD41B0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B1C39F-2779-926A-7618-F5A9369DE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091DD5-6887-EE9E-11DA-BF86269BF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97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89896-B1B2-8F0F-CA3D-1510130068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194196-F42B-F04E-7749-040BFC6EEA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8FA00F-BAC1-4705-E71B-FD65833E28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B638A5-5297-CBB6-47BF-266466287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8260B6-5A5B-8E84-4D0D-1392D019B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67425F-E9F7-DCBA-CDD0-B3B8D0616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151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ED2417-F295-40D4-A23E-30C33B402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C9308B-76F9-9088-B1C0-7EA3CC6110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32F9BF-5BEA-1456-4815-CAD143A3AC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63AC86-1C69-46A0-3C80-82AC49E0D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EF49DD-90E2-44A2-2438-98E8F934E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2C1D2E-1293-F51B-782F-B0CBB6F5D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58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CFD1-344B-1D4C-846D-04F06913E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C79CE-B0EC-D03B-3CA5-F0FC88E627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924A19-014F-3DF4-26F5-37526D1E3C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AF2A8E-8131-4D9B-A878-DFD17812B58E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CE7D23-72BA-B8F7-2B61-44795C54F4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B6A25A-1AF7-D5A2-CB69-485870F58D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23777E-30B8-48EA-94DB-866D605D0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825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2">
            <a:extLst>
              <a:ext uri="{FF2B5EF4-FFF2-40B4-BE49-F238E27FC236}">
                <a16:creationId xmlns:a16="http://schemas.microsoft.com/office/drawing/2014/main" id="{888E5576-809A-A0C0-DB95-154B38EEB35A}"/>
              </a:ext>
            </a:extLst>
          </p:cNvPr>
          <p:cNvSpPr txBox="1">
            <a:spLocks/>
          </p:cNvSpPr>
          <p:nvPr/>
        </p:nvSpPr>
        <p:spPr>
          <a:xfrm>
            <a:off x="77476" y="5812971"/>
            <a:ext cx="12192000" cy="819063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70000"/>
              </a:lnSpc>
              <a:buNone/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: The Na</a:t>
            </a:r>
            <a:r>
              <a:rPr lang="en-US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,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</a:t>
            </a:r>
            <a:r>
              <a:rPr lang="en-US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 and P related traits in 7 contrasting wheat genotypes under control (0 mM NaCl and salt stress (175 mM NaCl). C = control, S = Salinity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1D85096-639D-BCD2-9D42-1B99230212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486" y="521208"/>
            <a:ext cx="11212286" cy="4891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9681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090195-4BEF-BF0D-E4C8-29F1842423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2">
            <a:extLst>
              <a:ext uri="{FF2B5EF4-FFF2-40B4-BE49-F238E27FC236}">
                <a16:creationId xmlns:a16="http://schemas.microsoft.com/office/drawing/2014/main" id="{FE91EB15-E568-E394-7DF5-70D914E0DA92}"/>
              </a:ext>
            </a:extLst>
          </p:cNvPr>
          <p:cNvSpPr txBox="1">
            <a:spLocks/>
          </p:cNvSpPr>
          <p:nvPr/>
        </p:nvSpPr>
        <p:spPr>
          <a:xfrm>
            <a:off x="-1" y="6019801"/>
            <a:ext cx="12191999" cy="642256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70000"/>
              </a:lnSpc>
              <a:buNone/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Antioxidants enzymes activity; APX = Ascorbate Peroxidase, CAT = Catalase, SOD = Super Oxide Dismutase, and GR = Glutathione Reductase in 7 contrasting wheat genotypes and control (0 mM NaCl and salt stress (175 mM NaCl)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B7F60B0-67AC-463B-9519-C0E230843C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7241748"/>
              </p:ext>
            </p:extLst>
          </p:nvPr>
        </p:nvGraphicFramePr>
        <p:xfrm>
          <a:off x="-1" y="-1"/>
          <a:ext cx="11941629" cy="58238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177914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F3E27-3E2A-F9A5-7823-F939A67A49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16329" y="5788395"/>
            <a:ext cx="12224657" cy="1069605"/>
          </a:xfrm>
        </p:spPr>
        <p:txBody>
          <a:bodyPr/>
          <a:lstStyle/>
          <a:p>
            <a:pPr>
              <a:lnSpc>
                <a:spcPct val="70000"/>
              </a:lnSpc>
              <a:spcBef>
                <a:spcPts val="1000"/>
              </a:spcBef>
            </a:pPr>
            <a:r>
              <a:rPr lang="en-US" sz="1800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3: The logarithmic fold change of </a:t>
            </a:r>
            <a:r>
              <a:rPr lang="en-US" sz="1800" i="1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aAVP1 </a:t>
            </a:r>
            <a:r>
              <a:rPr lang="en-US" sz="1800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d </a:t>
            </a:r>
            <a:r>
              <a:rPr lang="en-US" sz="1800" i="1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HX1</a:t>
            </a:r>
            <a:r>
              <a:rPr lang="en-US" sz="1800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enes in four contrasting wheat genotypes; Sohag-5 “sensitive”, Javelin 48, Kandahar, 1018d “tolerant” 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AA04732-C1FA-3232-9A52-2F32AC21A0B4}"/>
              </a:ext>
            </a:extLst>
          </p:cNvPr>
          <p:cNvGrpSpPr/>
          <p:nvPr/>
        </p:nvGrpSpPr>
        <p:grpSpPr>
          <a:xfrm>
            <a:off x="1762172" y="87086"/>
            <a:ext cx="8667653" cy="5337994"/>
            <a:chOff x="2337802" y="838200"/>
            <a:chExt cx="7516394" cy="5033194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B82A5C57-3FF0-C0E1-18E3-22FC1294C806}"/>
                </a:ext>
              </a:extLst>
            </p:cNvPr>
            <p:cNvGrpSpPr/>
            <p:nvPr/>
          </p:nvGrpSpPr>
          <p:grpSpPr>
            <a:xfrm>
              <a:off x="2337802" y="838200"/>
              <a:ext cx="7516394" cy="5033194"/>
              <a:chOff x="2337802" y="838200"/>
              <a:chExt cx="7516394" cy="5033194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E4164D15-66B3-DD73-95F0-4DB540AE3896}"/>
                  </a:ext>
                </a:extLst>
              </p:cNvPr>
              <p:cNvGrpSpPr/>
              <p:nvPr/>
            </p:nvGrpSpPr>
            <p:grpSpPr>
              <a:xfrm>
                <a:off x="2337802" y="936563"/>
                <a:ext cx="7516394" cy="4934831"/>
                <a:chOff x="2337802" y="936563"/>
                <a:chExt cx="7516394" cy="4934831"/>
              </a:xfrm>
            </p:grpSpPr>
            <p:pic>
              <p:nvPicPr>
                <p:cNvPr id="4" name="Picture 3" descr="A graph of different colored columns">
                  <a:extLst>
                    <a:ext uri="{FF2B5EF4-FFF2-40B4-BE49-F238E27FC236}">
                      <a16:creationId xmlns:a16="http://schemas.microsoft.com/office/drawing/2014/main" id="{8CC19C27-5FCA-CA34-AD84-2EC94E6D6E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37802" y="1463986"/>
                  <a:ext cx="7516394" cy="4407408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933B2FA9-543B-401A-0763-516897E4B6E8}"/>
                    </a:ext>
                  </a:extLst>
                </p:cNvPr>
                <p:cNvSpPr txBox="1"/>
                <p:nvPr/>
              </p:nvSpPr>
              <p:spPr>
                <a:xfrm>
                  <a:off x="3597302" y="968829"/>
                  <a:ext cx="2558143" cy="3482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aAVP1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7E7B394-B1F6-A883-C7C8-ACEE130AC5D6}"/>
                    </a:ext>
                  </a:extLst>
                </p:cNvPr>
                <p:cNvSpPr txBox="1"/>
                <p:nvPr/>
              </p:nvSpPr>
              <p:spPr>
                <a:xfrm>
                  <a:off x="6411686" y="936563"/>
                  <a:ext cx="255814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HX1</a:t>
                  </a:r>
                </a:p>
              </p:txBody>
            </p:sp>
          </p:grp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0F837B51-10D7-587F-F2C9-82B655607400}"/>
                  </a:ext>
                </a:extLst>
              </p:cNvPr>
              <p:cNvCxnSpPr/>
              <p:nvPr/>
            </p:nvCxnSpPr>
            <p:spPr>
              <a:xfrm flipV="1">
                <a:off x="6564086" y="838200"/>
                <a:ext cx="0" cy="3537857"/>
              </a:xfrm>
              <a:prstGeom prst="line">
                <a:avLst/>
              </a:prstGeom>
              <a:ln w="28575" cap="flat" cmpd="sng" algn="ctr">
                <a:solidFill>
                  <a:srgbClr val="0000CC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</p:grp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58CC3829-C91B-9A3A-77C0-41A7D6528E23}"/>
                </a:ext>
              </a:extLst>
            </p:cNvPr>
            <p:cNvSpPr/>
            <p:nvPr/>
          </p:nvSpPr>
          <p:spPr>
            <a:xfrm>
              <a:off x="3733801" y="5214256"/>
              <a:ext cx="359228" cy="1362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00460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098</TotalTime>
  <Words>122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Figure S3: The logarithmic fold change of TaAVP1 and NHX1 genes in four contrasting wheat genotypes; Sohag-5 “sensitive”, Javelin 48, Kandahar, 1018d “tolerant”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ياسر شعبان سيد مرسى</dc:creator>
  <cp:lastModifiedBy>Yasser Moursi</cp:lastModifiedBy>
  <cp:revision>22</cp:revision>
  <dcterms:created xsi:type="dcterms:W3CDTF">2025-06-09T22:07:36Z</dcterms:created>
  <dcterms:modified xsi:type="dcterms:W3CDTF">2025-10-16T11:58:40Z</dcterms:modified>
</cp:coreProperties>
</file>